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24"/>
    <p:restoredTop sz="95946"/>
  </p:normalViewPr>
  <p:slideViewPr>
    <p:cSldViewPr snapToGrid="0" snapToObjects="1">
      <p:cViewPr varScale="1">
        <p:scale>
          <a:sx n="115" d="100"/>
          <a:sy n="115" d="100"/>
        </p:scale>
        <p:origin x="136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68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213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063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322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390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360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773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128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988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786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D0879-DB1B-014C-86CD-92415D941DD4}" type="datetimeFigureOut">
              <a:rPr lang="en-US" smtClean="0"/>
              <a:t>2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5381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CD0879-DB1B-014C-86CD-92415D941DD4}" type="datetimeFigureOut">
              <a:rPr lang="en-US" smtClean="0"/>
              <a:t>2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A3A470-C9EF-BB43-803F-63C932A95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784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3843FA6-A6E6-7049-AC71-CA2061E0CD3A}"/>
              </a:ext>
            </a:extLst>
          </p:cNvPr>
          <p:cNvSpPr txBox="1"/>
          <p:nvPr/>
        </p:nvSpPr>
        <p:spPr>
          <a:xfrm>
            <a:off x="654092" y="3782316"/>
            <a:ext cx="79264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The methylation status of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tRNA-Arg-TCT-4-1, tRNA-Ile-AAT-8-1, and tRNA-Val-CAC-2-1 is associated with their expression levels in </a:t>
            </a:r>
            <a:r>
              <a:rPr lang="en-GB" sz="900" b="1">
                <a:latin typeface="Arial" panose="020B0604020202020204" pitchFamily="34" charset="0"/>
                <a:cs typeface="Arial" panose="020B0604020202020204" pitchFamily="34" charset="0"/>
              </a:rPr>
              <a:t>TCGA tumors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 Volcano plot representing the Spearman’s correlation coefficient (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nd -log10 FDR of each computed Spearman’s correlation from Figure 1B. Statistically significant associations are shown in blue. (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Barplot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summarizing the tissue frequency of all the statistically significant negative associations between methylation and expression from panel A.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06ECECE-756C-8E4D-BE07-8E8206C78E94}"/>
              </a:ext>
            </a:extLst>
          </p:cNvPr>
          <p:cNvSpPr txBox="1"/>
          <p:nvPr/>
        </p:nvSpPr>
        <p:spPr>
          <a:xfrm>
            <a:off x="7168152" y="-38461"/>
            <a:ext cx="2050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283E78F-C2AA-4948-B147-8F3BF354BD50}"/>
              </a:ext>
            </a:extLst>
          </p:cNvPr>
          <p:cNvSpPr txBox="1"/>
          <p:nvPr/>
        </p:nvSpPr>
        <p:spPr>
          <a:xfrm>
            <a:off x="4417154" y="108043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14C2665-F6DB-6540-B1F1-CE06C728F809}"/>
              </a:ext>
            </a:extLst>
          </p:cNvPr>
          <p:cNvSpPr txBox="1"/>
          <p:nvPr/>
        </p:nvSpPr>
        <p:spPr>
          <a:xfrm>
            <a:off x="654092" y="108043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A42E3902-05A2-6046-8EA4-7D0BC691113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5000"/>
                    </a14:imgEffect>
                  </a14:imgLayer>
                </a14:imgProps>
              </a:ext>
            </a:extLst>
          </a:blip>
          <a:srcRect r="40244"/>
          <a:stretch/>
        </p:blipFill>
        <p:spPr>
          <a:xfrm>
            <a:off x="914119" y="1265102"/>
            <a:ext cx="2012037" cy="2020250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2EE8A3BD-2562-E641-890E-503D0B5D146D}"/>
              </a:ext>
            </a:extLst>
          </p:cNvPr>
          <p:cNvGrpSpPr/>
          <p:nvPr/>
        </p:nvGrpSpPr>
        <p:grpSpPr>
          <a:xfrm>
            <a:off x="2839544" y="1265102"/>
            <a:ext cx="1539115" cy="400484"/>
            <a:chOff x="3122341" y="924698"/>
            <a:chExt cx="1539115" cy="400484"/>
          </a:xfrm>
        </p:grpSpPr>
        <p:pic>
          <p:nvPicPr>
            <p:cNvPr id="50" name="Picture 49" descr="Chart, scatter chart&#10;&#10;Description automatically generated">
              <a:extLst>
                <a:ext uri="{FF2B5EF4-FFF2-40B4-BE49-F238E27FC236}">
                  <a16:creationId xmlns:a16="http://schemas.microsoft.com/office/drawing/2014/main" id="{63F9392A-B6A5-7E4A-86F8-AA277A0B6A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0176" t="33629" r="33158" b="47209"/>
            <a:stretch/>
          </p:blipFill>
          <p:spPr>
            <a:xfrm rot="10800000">
              <a:off x="3122341" y="965058"/>
              <a:ext cx="208819" cy="360124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D35E5A70-C16E-A241-9B5F-D9C9B400C2DC}"/>
                </a:ext>
              </a:extLst>
            </p:cNvPr>
            <p:cNvSpPr txBox="1"/>
            <p:nvPr/>
          </p:nvSpPr>
          <p:spPr>
            <a:xfrm>
              <a:off x="3231256" y="924698"/>
              <a:ext cx="143020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ρ</a:t>
              </a:r>
              <a:r>
                <a:rPr lang="en-ES" sz="900" dirty="0">
                  <a:latin typeface="Arial" panose="020B0604020202020204" pitchFamily="34" charset="0"/>
                  <a:cs typeface="Arial" panose="020B0604020202020204" pitchFamily="34" charset="0"/>
                </a:rPr>
                <a:t> ≤ -0.2 and FDR ≤ 0.05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C6B81FF5-1C6F-4447-9647-25021E3C24DD}"/>
                </a:ext>
              </a:extLst>
            </p:cNvPr>
            <p:cNvSpPr txBox="1"/>
            <p:nvPr/>
          </p:nvSpPr>
          <p:spPr>
            <a:xfrm>
              <a:off x="3231256" y="1084750"/>
              <a:ext cx="90922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Not</a:t>
              </a:r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ignificant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7" name="Picture 6" descr="Chart, histogram&#10;&#10;Description automatically generated">
            <a:extLst>
              <a:ext uri="{FF2B5EF4-FFF2-40B4-BE49-F238E27FC236}">
                <a16:creationId xmlns:a16="http://schemas.microsoft.com/office/drawing/2014/main" id="{F7A1C212-36F9-EE4A-9FE5-F9279D721B5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  <a14:imgEffect>
                      <a14:brightnessContrast bright="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719784" y="1244602"/>
            <a:ext cx="3860800" cy="23164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6414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7</TotalTime>
  <Words>96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GALIDA ROSSELLO TORTELLA</dc:creator>
  <cp:lastModifiedBy>MARGALIDA ROSSELLO TORTELLA</cp:lastModifiedBy>
  <cp:revision>19</cp:revision>
  <dcterms:created xsi:type="dcterms:W3CDTF">2021-07-05T11:21:51Z</dcterms:created>
  <dcterms:modified xsi:type="dcterms:W3CDTF">2022-02-02T09:51:45Z</dcterms:modified>
</cp:coreProperties>
</file>